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4211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F7843-FB3A-4570-83D2-F2BDC5FCBA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4C16F-EF0B-44E2-A2EC-4F50E0DA1D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4931C-28D8-426B-88C2-866404AE51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C32BF-CC3A-486D-A9D2-67E3E82FF3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9F796-1BC9-4561-9FE6-2EC747807F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7A040-E2A2-43AF-99DD-8B39227B58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2712C-3E8A-465D-908B-BF2098CF4C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B9E87-BEEE-4BC9-BE26-719FE731CA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B9E66F-B5C0-4F1A-88C0-FF1A362C2E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840EE-3B7C-420E-9817-909C4C32E2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D0A2C-E0FC-497D-BB55-0F1EB65E12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D5DF2-144A-4A04-A6C3-DA7183A3DF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5D886F-BE62-40B9-9193-CD4651590D3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362320" y="1784520"/>
            <a:ext cx="1676160" cy="1447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968840" y="342900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2059200" y="135576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2403000" y="3909960"/>
            <a:ext cx="4511880" cy="1101960"/>
            <a:chOff x="2403000" y="3909960"/>
            <a:chExt cx="4511880" cy="1101960"/>
          </a:xfrm>
        </p:grpSpPr>
        <p:sp>
          <p:nvSpPr>
            <p:cNvPr id="45" name=""/>
            <p:cNvSpPr/>
            <p:nvPr/>
          </p:nvSpPr>
          <p:spPr>
            <a:xfrm>
              <a:off x="2761920" y="4457880"/>
              <a:ext cx="4152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403000" y="4443480"/>
              <a:ext cx="1064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retreatmen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476880" y="420228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 h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172040" y="4437000"/>
              <a:ext cx="39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 h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587920" y="4176720"/>
              <a:ext cx="47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1 h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375240" y="4469040"/>
              <a:ext cx="47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4 h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733480" y="3909960"/>
              <a:ext cx="45972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R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178160" y="3909960"/>
              <a:ext cx="45972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R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416640" y="3909960"/>
              <a:ext cx="45972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R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309120" y="4735440"/>
              <a:ext cx="72468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-83-0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430240" y="4735440"/>
              <a:ext cx="724680" cy="276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-83-0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952360" y="421956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387680" y="421632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626160" y="421632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3673080" y="449244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5794200" y="4479480"/>
              <a:ext cx="0" cy="228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1" name=""/>
          <p:cNvSpPr/>
          <p:nvPr/>
        </p:nvSpPr>
        <p:spPr>
          <a:xfrm>
            <a:off x="5784480" y="5518080"/>
            <a:ext cx="309780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emental data</a:t>
            </a:r>
            <a:r>
              <a:rPr b="0" lang="zh-CN" sz="2400" spc="-1" strike="noStrike">
                <a:solidFill>
                  <a:srgbClr val="000000"/>
                </a:solidFill>
                <a:latin typeface="Arial"/>
              </a:rPr>
              <a:t>　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. S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5200560" y="2241720"/>
            <a:ext cx="3925800" cy="2671560"/>
          </a:xfrm>
          <a:prstGeom prst="rect">
            <a:avLst/>
          </a:prstGeom>
          <a:ln w="0">
            <a:noFill/>
          </a:ln>
        </p:spPr>
      </p:pic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562720" y="5924520"/>
            <a:ext cx="358128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emental data</a:t>
            </a:r>
            <a:r>
              <a:rPr b="0" lang="zh-CN" sz="2400" spc="-1" strike="noStrike">
                <a:solidFill>
                  <a:srgbClr val="000000"/>
                </a:solidFill>
                <a:latin typeface="Arial"/>
              </a:rPr>
              <a:t>　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. S2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5" name="" descr=""/>
          <p:cNvPicPr/>
          <p:nvPr/>
        </p:nvPicPr>
        <p:blipFill>
          <a:blip r:embed="rId2"/>
          <a:stretch/>
        </p:blipFill>
        <p:spPr>
          <a:xfrm>
            <a:off x="866880" y="2093760"/>
            <a:ext cx="4087800" cy="2868840"/>
          </a:xfrm>
          <a:prstGeom prst="rect">
            <a:avLst/>
          </a:prstGeom>
          <a:ln w="0">
            <a:noFill/>
          </a:ln>
        </p:spPr>
      </p:pic>
      <p:sp>
        <p:nvSpPr>
          <p:cNvPr id="66" name=""/>
          <p:cNvSpPr/>
          <p:nvPr/>
        </p:nvSpPr>
        <p:spPr>
          <a:xfrm>
            <a:off x="888840" y="1492200"/>
            <a:ext cx="355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5178600" y="1492200"/>
            <a:ext cx="355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4147200" y="3181680"/>
            <a:ext cx="2467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IAUGC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60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(Gd mmol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・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sec/L)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1995480" y="1641600"/>
            <a:ext cx="206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Y364947, 1 mg/kg, i.p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6502320" y="1771560"/>
            <a:ext cx="88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AUG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1T03:14:05Z</dcterms:created>
  <dc:creator>minowayasusi</dc:creator>
  <dc:description/>
  <dc:language>en-US</dc:language>
  <cp:lastModifiedBy>gk.janakiraman</cp:lastModifiedBy>
  <dcterms:modified xsi:type="dcterms:W3CDTF">2009-10-28T10:45:47Z</dcterms:modified>
  <cp:revision>191</cp:revision>
  <dc:subject/>
  <dc:title>Fig　 Antiangiogenic Activity Evaluated by Dynamic Contrast-Enhanced Magnetic Resonance Imaging with Magnevist and liposomal contrast agent</dc:title>
</cp:coreProperties>
</file>